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641" r:id="rId2"/>
    <p:sldId id="654" r:id="rId3"/>
    <p:sldId id="657" r:id="rId4"/>
    <p:sldId id="655" r:id="rId5"/>
    <p:sldId id="656" r:id="rId6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C6D9"/>
    <a:srgbClr val="AE78D6"/>
    <a:srgbClr val="CABC0C"/>
    <a:srgbClr val="10A028"/>
    <a:srgbClr val="DD97BA"/>
    <a:srgbClr val="993366"/>
    <a:srgbClr val="CC6600"/>
    <a:srgbClr val="E5B1CB"/>
    <a:srgbClr val="B13975"/>
    <a:srgbClr val="CE68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62" autoAdjust="0"/>
    <p:restoredTop sz="98029" autoAdjust="0"/>
  </p:normalViewPr>
  <p:slideViewPr>
    <p:cSldViewPr snapToGrid="0">
      <p:cViewPr varScale="1">
        <p:scale>
          <a:sx n="79" d="100"/>
          <a:sy n="79" d="100"/>
        </p:scale>
        <p:origin x="816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74B8FD-5004-4A34-986E-4BA245B3E63F}" type="datetimeFigureOut">
              <a:rPr lang="hu-HU" smtClean="0"/>
              <a:pPr/>
              <a:t>2022. 08. 24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7905E-B314-4604-AFF2-A2ECFC78EA8C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4288508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C483F6-14AB-454E-935A-A5AB3645DA92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83099B-FAFC-4DBA-A41B-A77A0A94FA1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276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5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619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064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606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201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90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443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433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023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305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47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15DE7-1CB4-416C-90D9-5A32E064AE89}" type="datetimeFigureOut">
              <a:rPr lang="en-US" smtClean="0"/>
              <a:pPr/>
              <a:t>2022-08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9471F-255A-4FAE-99E8-0555F38EB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319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-1" y="0"/>
            <a:ext cx="6045959" cy="147732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hu-HU" b="1" dirty="0"/>
              <a:t>S</a:t>
            </a:r>
            <a:r>
              <a:rPr lang="en-US" b="1" dirty="0" err="1"/>
              <a:t>upplementary</a:t>
            </a:r>
            <a:r>
              <a:rPr lang="en-US" b="1" dirty="0"/>
              <a:t> </a:t>
            </a:r>
            <a:r>
              <a:rPr lang="hu-HU" b="1" dirty="0"/>
              <a:t>Figure S1:</a:t>
            </a:r>
            <a:r>
              <a:rPr lang="en-US" b="1" dirty="0"/>
              <a:t> </a:t>
            </a:r>
            <a:endParaRPr lang="hu-HU" b="1" dirty="0"/>
          </a:p>
          <a:p>
            <a:r>
              <a:rPr lang="en-US" dirty="0"/>
              <a:t>ARID1A protein</a:t>
            </a:r>
            <a:r>
              <a:rPr lang="hu-HU" dirty="0"/>
              <a:t> </a:t>
            </a:r>
            <a:r>
              <a:rPr lang="hu-HU" dirty="0" err="1"/>
              <a:t>levels</a:t>
            </a:r>
            <a:r>
              <a:rPr lang="hu-HU" dirty="0"/>
              <a:t> </a:t>
            </a:r>
            <a:r>
              <a:rPr lang="hu-HU" dirty="0" err="1"/>
              <a:t>after</a:t>
            </a:r>
            <a:r>
              <a:rPr lang="hu-HU" dirty="0"/>
              <a:t> 6 </a:t>
            </a:r>
            <a:r>
              <a:rPr lang="hu-HU" dirty="0" err="1"/>
              <a:t>hours</a:t>
            </a:r>
            <a:r>
              <a:rPr lang="hu-HU" dirty="0"/>
              <a:t> of </a:t>
            </a:r>
            <a:r>
              <a:rPr lang="hu-HU" dirty="0" err="1"/>
              <a:t>Bex</a:t>
            </a:r>
            <a:r>
              <a:rPr lang="hu-HU" dirty="0"/>
              <a:t>+</a:t>
            </a:r>
            <a:r>
              <a:rPr lang="hu-HU" dirty="0" err="1"/>
              <a:t>Carv</a:t>
            </a:r>
            <a:r>
              <a:rPr lang="hu-HU" dirty="0"/>
              <a:t> </a:t>
            </a:r>
            <a:r>
              <a:rPr lang="hu-HU" dirty="0" err="1"/>
              <a:t>treatment</a:t>
            </a:r>
            <a:endParaRPr lang="hu-HU" dirty="0"/>
          </a:p>
          <a:p>
            <a:r>
              <a:rPr lang="en-US" dirty="0"/>
              <a:t>Western </a:t>
            </a:r>
            <a:r>
              <a:rPr lang="hu-HU" dirty="0"/>
              <a:t>b</a:t>
            </a:r>
            <a:r>
              <a:rPr lang="en-US" dirty="0"/>
              <a:t>lot</a:t>
            </a:r>
            <a:r>
              <a:rPr lang="hu-HU" dirty="0"/>
              <a:t>s and </a:t>
            </a:r>
            <a:r>
              <a:rPr lang="hu-HU" dirty="0" err="1"/>
              <a:t>densitometric</a:t>
            </a:r>
            <a:r>
              <a:rPr lang="hu-HU" dirty="0"/>
              <a:t> </a:t>
            </a:r>
            <a:r>
              <a:rPr lang="hu-HU" dirty="0" err="1"/>
              <a:t>evaluation</a:t>
            </a:r>
            <a:r>
              <a:rPr lang="hu-HU" dirty="0"/>
              <a:t> of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results</a:t>
            </a:r>
            <a:endParaRPr lang="en-US" dirty="0"/>
          </a:p>
          <a:p>
            <a:endParaRPr lang="ar-SY" dirty="0"/>
          </a:p>
          <a:p>
            <a:endParaRPr lang="ar-SY" b="1" dirty="0"/>
          </a:p>
        </p:txBody>
      </p:sp>
      <p:sp>
        <p:nvSpPr>
          <p:cNvPr id="19" name="TextBox 10"/>
          <p:cNvSpPr txBox="1"/>
          <p:nvPr/>
        </p:nvSpPr>
        <p:spPr>
          <a:xfrm>
            <a:off x="3504480" y="3103983"/>
            <a:ext cx="4812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=3</a:t>
            </a:r>
          </a:p>
        </p:txBody>
      </p:sp>
      <p:pic>
        <p:nvPicPr>
          <p:cNvPr id="29" name="Picture 1039" descr="E:\WORK\-PhD Debrecen-\PhD\Research\Research work\Literature review\PhD_Dissertation_Introduction\ARID1A_literature_review\MY Manuscript\HMEC-hTert\ARID1A_Protein_6h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12117" y="1310531"/>
            <a:ext cx="2944813" cy="1597025"/>
          </a:xfrm>
          <a:prstGeom prst="rect">
            <a:avLst/>
          </a:prstGeom>
          <a:noFill/>
        </p:spPr>
      </p:pic>
      <p:graphicFrame>
        <p:nvGraphicFramePr>
          <p:cNvPr id="30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8687144"/>
              </p:ext>
            </p:extLst>
          </p:nvPr>
        </p:nvGraphicFramePr>
        <p:xfrm>
          <a:off x="1000537" y="3180715"/>
          <a:ext cx="3167972" cy="2045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6871389" imgH="4436738" progId="Prism6.Document">
                  <p:embed/>
                </p:oleObj>
              </mc:Choice>
              <mc:Fallback>
                <p:oleObj name="Prism 6" r:id="rId3" imgW="6871389" imgH="4436738" progId="Prism6.Document">
                  <p:embed/>
                  <p:pic>
                    <p:nvPicPr>
                      <p:cNvPr id="0" name="Picture 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00537" y="3180715"/>
                        <a:ext cx="3167972" cy="204586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-1" y="0"/>
            <a:ext cx="5099539" cy="147732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hu-HU" b="1" dirty="0"/>
              <a:t>S</a:t>
            </a:r>
            <a:r>
              <a:rPr lang="en-US" b="1" dirty="0" err="1"/>
              <a:t>upplementary</a:t>
            </a:r>
            <a:r>
              <a:rPr lang="en-US" b="1" dirty="0"/>
              <a:t> </a:t>
            </a:r>
            <a:r>
              <a:rPr lang="hu-HU" b="1" dirty="0"/>
              <a:t>Figure S</a:t>
            </a:r>
            <a:r>
              <a:rPr lang="en-US" b="1" dirty="0"/>
              <a:t>2</a:t>
            </a:r>
            <a:r>
              <a:rPr lang="hu-HU" b="1" dirty="0"/>
              <a:t>:</a:t>
            </a:r>
            <a:r>
              <a:rPr lang="en-US" b="1" dirty="0"/>
              <a:t> </a:t>
            </a:r>
            <a:endParaRPr lang="hu-HU" b="1" dirty="0"/>
          </a:p>
          <a:p>
            <a:r>
              <a:rPr lang="en-US" dirty="0"/>
              <a:t>Venn diagram to depict the intersection of genomic </a:t>
            </a:r>
          </a:p>
          <a:p>
            <a:r>
              <a:rPr lang="en-US" dirty="0"/>
              <a:t>ARID1A occupancy and  altered gene expression</a:t>
            </a:r>
          </a:p>
          <a:p>
            <a:endParaRPr lang="ar-SY" dirty="0"/>
          </a:p>
          <a:p>
            <a:endParaRPr lang="ar-SY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070" y="1760102"/>
            <a:ext cx="3185395" cy="2752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70772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-1" y="0"/>
            <a:ext cx="5099539" cy="120032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hu-HU" b="1" dirty="0"/>
              <a:t>S</a:t>
            </a:r>
            <a:r>
              <a:rPr lang="en-US" b="1" dirty="0" err="1"/>
              <a:t>upplementary</a:t>
            </a:r>
            <a:r>
              <a:rPr lang="en-US" b="1" dirty="0"/>
              <a:t> </a:t>
            </a:r>
            <a:r>
              <a:rPr lang="en-US" b="1" dirty="0" err="1"/>
              <a:t>Tabl</a:t>
            </a:r>
            <a:r>
              <a:rPr lang="hu-HU" b="1" dirty="0"/>
              <a:t>e S</a:t>
            </a:r>
            <a:r>
              <a:rPr lang="en-US" b="1" dirty="0"/>
              <a:t>1</a:t>
            </a:r>
            <a:r>
              <a:rPr lang="hu-HU" b="1" dirty="0"/>
              <a:t>:</a:t>
            </a:r>
            <a:r>
              <a:rPr lang="en-US" b="1" dirty="0"/>
              <a:t> </a:t>
            </a:r>
            <a:endParaRPr lang="hu-HU" b="1" dirty="0"/>
          </a:p>
          <a:p>
            <a:r>
              <a:rPr lang="en-US" dirty="0"/>
              <a:t>Antibodies used in the study</a:t>
            </a:r>
          </a:p>
          <a:p>
            <a:endParaRPr lang="ar-SY" dirty="0"/>
          </a:p>
          <a:p>
            <a:endParaRPr lang="ar-SY" b="1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03574" y="937026"/>
          <a:ext cx="4892388" cy="571912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9902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6947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238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8087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Antibody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atalog no. Company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oncentration/assay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4009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kern="1800">
                          <a:effectLst/>
                        </a:rPr>
                        <a:t>Acetyl-Histone H3 (K27) rabbit monoclonal antibody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kern="1800">
                          <a:effectLst/>
                        </a:rPr>
                        <a:t>Cell Signaling, 8173s, Lot # 6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4 µl/IP/ChIP-Seq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2 µl/IP/ChIP-qPCR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80188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RID1A rabbit monoclonal antibody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bcam, ab182560, Lot # GR3240244-2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4 µg/IP/ChIP-qPCR</a:t>
                      </a:r>
                    </a:p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8 μg/IP/ChIP-Seq 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1:500 / WB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1:1000/ IC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499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RID1A mouse monoclonal antibody 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anta Cruz Biotechnology, PSG3X, sc-32761x, Lot# C0116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8 μg/IP/ChIP-Seq 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4009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β-actin mouse </a:t>
                      </a:r>
                      <a:r>
                        <a:rPr lang="en-US" sz="1000" kern="1800" dirty="0">
                          <a:effectLst/>
                        </a:rPr>
                        <a:t>monoclonal antibody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NOVUS, NBP1-47423, </a:t>
                      </a:r>
                      <a:r>
                        <a:rPr lang="en-US" sz="1000" kern="1800">
                          <a:effectLst/>
                        </a:rPr>
                        <a:t>Lot # C-5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1:1000 /WB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4009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BRG1 rabbit monoclonal antibody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bcam, ab110641, Lot # GR3208604-17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2.5 µg/IP/ChIP-qPCR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9880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E-cadherin rat monoclonal antibody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800">
                          <a:effectLst/>
                        </a:rPr>
                        <a:t>Invitrogen, 14-3249-82, Lot # 2340002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:100/I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4009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Fibronectin rabbit polyclonal antibody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kern="1800">
                          <a:effectLst/>
                        </a:rPr>
                        <a:t>Invitrogen, PA5-29578, Lot </a:t>
                      </a:r>
                      <a:r>
                        <a:rPr lang="en-US" sz="1000">
                          <a:effectLst/>
                        </a:rPr>
                        <a:t># WI3371694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1:50/ICC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999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FOXQ1 mouse monoclonal antibody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kern="1800">
                          <a:effectLst/>
                        </a:rPr>
                        <a:t>Invitrogen, MA5-26943, Lot # VL3143634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:250/ WB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4009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N-cadherin mouse monoclonal antibody 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kern="1800">
                          <a:effectLst/>
                        </a:rPr>
                        <a:t>Invitrogen, MA1-159, , Lot </a:t>
                      </a:r>
                      <a:r>
                        <a:rPr lang="en-US" sz="1000">
                          <a:effectLst/>
                        </a:rPr>
                        <a:t># VH312184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1:50/ICC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4009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Negative control for Rabbit IgG Ab-1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NeoMarkers, NC-100-P1, Lot # 100P18118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4 µg/IP/ChIP-qPCR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44997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Normal mouse IgG1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anta Cruz, sc-3877, Lot# K0127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4 μg/IP/ChIP-qPCR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4009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SMAD4 rabbit monoclonal antibody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kern="1800">
                          <a:effectLst/>
                        </a:rPr>
                        <a:t>Thermo scientific, 701682, (10H10L15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1:250/ ICC</a:t>
                      </a:r>
                    </a:p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90" marR="4829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14697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-1" y="0"/>
            <a:ext cx="5099539" cy="120032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hu-HU" b="1" dirty="0"/>
              <a:t>S</a:t>
            </a:r>
            <a:r>
              <a:rPr lang="en-US" b="1" dirty="0" err="1"/>
              <a:t>upplementary</a:t>
            </a:r>
            <a:r>
              <a:rPr lang="en-US" b="1" dirty="0"/>
              <a:t> </a:t>
            </a:r>
            <a:r>
              <a:rPr lang="en-US" b="1" dirty="0" err="1"/>
              <a:t>Tabl</a:t>
            </a:r>
            <a:r>
              <a:rPr lang="hu-HU" b="1" dirty="0"/>
              <a:t>e S</a:t>
            </a:r>
            <a:r>
              <a:rPr lang="en-US" b="1" dirty="0"/>
              <a:t>2</a:t>
            </a:r>
            <a:r>
              <a:rPr lang="hu-HU" b="1" dirty="0"/>
              <a:t>:</a:t>
            </a:r>
            <a:r>
              <a:rPr lang="en-US" b="1" dirty="0"/>
              <a:t> </a:t>
            </a:r>
            <a:endParaRPr lang="hu-HU" b="1" dirty="0"/>
          </a:p>
          <a:p>
            <a:r>
              <a:rPr lang="en-US" dirty="0"/>
              <a:t>Sequences of the </a:t>
            </a:r>
            <a:r>
              <a:rPr lang="en-US" dirty="0" err="1"/>
              <a:t>oligos</a:t>
            </a:r>
            <a:r>
              <a:rPr lang="en-US" dirty="0"/>
              <a:t> used in RT-qPCR measurements</a:t>
            </a:r>
            <a:endParaRPr lang="ar-SY" dirty="0"/>
          </a:p>
          <a:p>
            <a:endParaRPr lang="ar-SY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0959939"/>
              </p:ext>
            </p:extLst>
          </p:nvPr>
        </p:nvGraphicFramePr>
        <p:xfrm>
          <a:off x="257884" y="1514549"/>
          <a:ext cx="6670454" cy="41405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285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577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6132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2288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60509">
                <a:tc rowSpan="2"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Gene Name or Symbol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 gridSpan="3"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Primers 5 '                           3'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41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Probes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74339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ARID1A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GCCAGTCGGACAGCATCA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TCTGCATATAACCTCGATCTTG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FAM-CCTTCCATGAACCAATCAAGCATTGCC-BHQ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74339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β-actin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CCTGGCACCCAGCA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GCCGATCCACACGGAGTA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FAM-ATCAAGATCATTGCTCCTCCTGAGCGC-BHQ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74339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BMP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GAATGCTCCTTCCCACTCAA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AGGTGAACCAAGGTCTGCACA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FAM-CACACATGAATGCAACCAACCACGC-BHQ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66118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Fibronectin 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GAGAGTCAGCCTCTGGTTCAGA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TGGAATCGACATCCACATCAG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TGCCAGTCCTTTAGGGCGATCAATGT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74339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FOXQ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TTTCCGCGGCAGCTACA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ACCTTGACGAAGCAGTCGT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FAM-CGAAAGGTTGTGGCGCACGGAG -BHQ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6226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KLF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GCTTGCGGCGGTAGCA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TCAGCGAATTGGAGAGAATAAAGT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SYBR Green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74339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N-Cadherin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TCCTGCTTATCCTTGTGCTGAT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TTGTTTGGCCTGGCGTTC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FAM-TGGTATGGATGAAACGCCGGGA-BHQ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74339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TGFBR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CATGAAGGACAACGTGTTGAGA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CTGGTGGTTGAGCCAGAA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FAM-ATCGAGGGCGACCAGAAATTCCCA-BHQ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246" marR="56246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cxnSp>
        <p:nvCxnSpPr>
          <p:cNvPr id="6" name="Straight Arrow Connector 5"/>
          <p:cNvCxnSpPr>
            <a:cxnSpLocks/>
          </p:cNvCxnSpPr>
          <p:nvPr/>
        </p:nvCxnSpPr>
        <p:spPr bwMode="auto">
          <a:xfrm>
            <a:off x="5576888" y="11164888"/>
            <a:ext cx="717550" cy="0"/>
          </a:xfrm>
          <a:prstGeom prst="straightConnector1">
            <a:avLst/>
          </a:prstGeom>
          <a:noFill/>
          <a:ln w="6350">
            <a:solidFill>
              <a:schemeClr val="dk1">
                <a:lumMod val="100000"/>
                <a:lumOff val="0"/>
              </a:schemeClr>
            </a:solidFill>
            <a:miter lim="800000"/>
            <a:headEnd/>
            <a:tailEnd type="triangle" w="med" len="med"/>
          </a:ln>
        </p:spPr>
      </p:cxn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257884" y="5838464"/>
            <a:ext cx="385691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M, 5-carboxyfluorescein; BHQ, black hole quencher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50368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-1" y="0"/>
            <a:ext cx="5099539" cy="120032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hu-HU" b="1" dirty="0"/>
              <a:t>S</a:t>
            </a:r>
            <a:r>
              <a:rPr lang="en-US" b="1" dirty="0" err="1"/>
              <a:t>upplementary</a:t>
            </a:r>
            <a:r>
              <a:rPr lang="en-US" b="1" dirty="0"/>
              <a:t> </a:t>
            </a:r>
            <a:r>
              <a:rPr lang="en-US" b="1" dirty="0" err="1"/>
              <a:t>Tabl</a:t>
            </a:r>
            <a:r>
              <a:rPr lang="hu-HU" b="1" dirty="0"/>
              <a:t>e S</a:t>
            </a:r>
            <a:r>
              <a:rPr lang="en-US" b="1" dirty="0"/>
              <a:t>3</a:t>
            </a:r>
            <a:r>
              <a:rPr lang="hu-HU" b="1" dirty="0"/>
              <a:t>:</a:t>
            </a:r>
            <a:r>
              <a:rPr lang="en-US" b="1" dirty="0"/>
              <a:t> </a:t>
            </a:r>
            <a:endParaRPr lang="hu-HU" b="1" dirty="0"/>
          </a:p>
          <a:p>
            <a:r>
              <a:rPr lang="en-US" dirty="0"/>
              <a:t>Primer sequences against ARID1A target regions used for </a:t>
            </a:r>
            <a:r>
              <a:rPr lang="en-US" dirty="0" err="1"/>
              <a:t>ChIP</a:t>
            </a:r>
            <a:r>
              <a:rPr lang="en-US" dirty="0"/>
              <a:t>-qPCR</a:t>
            </a:r>
            <a:endParaRPr lang="ar-SY" dirty="0"/>
          </a:p>
          <a:p>
            <a:endParaRPr lang="ar-SY" b="1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9941959"/>
              </p:ext>
            </p:extLst>
          </p:nvPr>
        </p:nvGraphicFramePr>
        <p:xfrm>
          <a:off x="203158" y="1023769"/>
          <a:ext cx="5895185" cy="239187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486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308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308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8483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</a:rPr>
                        <a:t>Gene Name or Symbol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 gridSpan="2"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                   Primers 5'                       3'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Genomic Loci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99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905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BMP6_-27Kb to TSS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TTCATGCCAACATGGATCA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TCTTTAAACTCTTTGAATTCTTGCTT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hr6:7,698,428-7,698,499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59896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FOXQ1_+13Kb to TSS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TGTTTGCCTCACCGATCC</a:t>
                      </a:r>
                    </a:p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AACAGAATGACTCAAAGGGTGAT</a:t>
                      </a:r>
                    </a:p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chr6:1,326,070-1,326,148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905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KLF4_-14Kb  to TSS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CACTGGGCAGTGTTCGAG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TGGGGCAAACTGGTGGTA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hr9:110,266,666-110,266,728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4905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TGFBR2_-9Kb to TSS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AATAACCAATGAGTCTATTGTCAGGT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TTTTACCTTCAGGCATTTCAAA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chr3:30,638,800-30,638,867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49054"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</a:rPr>
                        <a:t>TGFBR2_+52Kb to TSS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</a:rPr>
                        <a:t>ACTGCTGGTGCTGTAGCAA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CGCAGTGGGAGAGACCT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</a:rPr>
                        <a:t>chr3:30,701,216-30,701,27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085" marR="62085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6688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71</TotalTime>
  <Words>438</Words>
  <Application>Microsoft Office PowerPoint</Application>
  <PresentationFormat>Widescreen</PresentationFormat>
  <Paragraphs>129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D work</dc:title>
  <dc:creator>Sham</dc:creator>
  <cp:lastModifiedBy>MDPI-109</cp:lastModifiedBy>
  <cp:revision>1384</cp:revision>
  <cp:lastPrinted>2022-06-02T06:26:13Z</cp:lastPrinted>
  <dcterms:created xsi:type="dcterms:W3CDTF">2020-06-16T12:32:21Z</dcterms:created>
  <dcterms:modified xsi:type="dcterms:W3CDTF">2022-08-24T13:28:12Z</dcterms:modified>
</cp:coreProperties>
</file>